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3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29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820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7159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6914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5753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7575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7690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5989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420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8396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7076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5038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BD4B4-F601-431B-80B5-A52F164EE5FD}" type="datetimeFigureOut">
              <a:rPr lang="ko-KR" altLang="en-US" smtClean="0"/>
              <a:t>2023-03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EE66B-CFC9-4AA3-9D38-CD8F72C779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1603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g"/><Relationship Id="rId4" Type="http://schemas.openxmlformats.org/officeDocument/2006/relationships/image" Target="../media/image3.emf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그룹 28"/>
          <p:cNvGrpSpPr/>
          <p:nvPr/>
        </p:nvGrpSpPr>
        <p:grpSpPr>
          <a:xfrm>
            <a:off x="5298950" y="181858"/>
            <a:ext cx="3776235" cy="6002925"/>
            <a:chOff x="4468637" y="181858"/>
            <a:chExt cx="3776235" cy="6002925"/>
          </a:xfrm>
        </p:grpSpPr>
        <p:sp>
          <p:nvSpPr>
            <p:cNvPr id="8" name="TextBox 7"/>
            <p:cNvSpPr txBox="1"/>
            <p:nvPr/>
          </p:nvSpPr>
          <p:spPr>
            <a:xfrm>
              <a:off x="4597994" y="5169120"/>
              <a:ext cx="202972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: marker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: 10% FBS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2 : 0% FBS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3 : Con (=pLKO.1)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4 : hST8Sia I </a:t>
              </a:r>
              <a:r>
                <a:rPr lang="en-US" altLang="ko-K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7994" y="181858"/>
              <a:ext cx="1432560" cy="202996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468637" y="396284"/>
              <a:ext cx="314510" cy="17697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endPara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endParaRPr lang="en-US" altLang="ko-KR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grpSp>
          <p:nvGrpSpPr>
            <p:cNvPr id="28" name="그룹 27"/>
            <p:cNvGrpSpPr/>
            <p:nvPr/>
          </p:nvGrpSpPr>
          <p:grpSpPr>
            <a:xfrm>
              <a:off x="4597994" y="2138717"/>
              <a:ext cx="3646878" cy="2924350"/>
              <a:chOff x="4597994" y="2138717"/>
              <a:chExt cx="3646878" cy="2924350"/>
            </a:xfrm>
          </p:grpSpPr>
          <p:pic>
            <p:nvPicPr>
              <p:cNvPr id="23" name="그림 22"/>
              <p:cNvPicPr>
                <a:picLocks noChangeAspect="1"/>
              </p:cNvPicPr>
              <p:nvPr/>
            </p:nvPicPr>
            <p:blipFill rotWithShape="1">
              <a:blip r:embed="rId3"/>
              <a:srcRect l="10717" t="6876" r="6904" b="5224"/>
              <a:stretch/>
            </p:blipFill>
            <p:spPr>
              <a:xfrm>
                <a:off x="4749800" y="2620433"/>
                <a:ext cx="1913468" cy="1291168"/>
              </a:xfrm>
              <a:prstGeom prst="rect">
                <a:avLst/>
              </a:prstGeom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4597994" y="2138717"/>
                <a:ext cx="20489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D3 synthase (hST8Sia I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flipH="1">
                <a:off x="4672188" y="2326220"/>
                <a:ext cx="1440916" cy="227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 1    2    3   4   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597994" y="4013961"/>
                <a:ext cx="739305" cy="1775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7" name="그림 26"/>
              <p:cNvPicPr>
                <a:picLocks noChangeAspect="1"/>
              </p:cNvPicPr>
              <p:nvPr/>
            </p:nvPicPr>
            <p:blipFill rotWithShape="1">
              <a:blip r:embed="rId4"/>
              <a:srcRect l="5456" t="6870" b="7414"/>
              <a:stretch/>
            </p:blipFill>
            <p:spPr>
              <a:xfrm>
                <a:off x="4631267" y="4279900"/>
                <a:ext cx="2259711" cy="783167"/>
              </a:xfrm>
              <a:prstGeom prst="rect">
                <a:avLst/>
              </a:prstGeom>
            </p:spPr>
          </p:pic>
          <p:sp>
            <p:nvSpPr>
              <p:cNvPr id="14" name="이등변 삼각형 13"/>
              <p:cNvSpPr/>
              <p:nvPr/>
            </p:nvSpPr>
            <p:spPr>
              <a:xfrm rot="16200000">
                <a:off x="6845175" y="3185134"/>
                <a:ext cx="109865" cy="154229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912030" y="3119617"/>
                <a:ext cx="9404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50kD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" name="직선 연결선 15"/>
              <p:cNvCxnSpPr/>
              <p:nvPr/>
            </p:nvCxnSpPr>
            <p:spPr>
              <a:xfrm flipV="1">
                <a:off x="5873448" y="3267737"/>
                <a:ext cx="871491" cy="72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이등변 삼각형 10"/>
              <p:cNvSpPr/>
              <p:nvPr/>
            </p:nvSpPr>
            <p:spPr>
              <a:xfrm rot="16200000">
                <a:off x="7048720" y="4751134"/>
                <a:ext cx="109865" cy="184806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117939" y="4700906"/>
                <a:ext cx="112693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37kD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직선 연결선 12"/>
              <p:cNvCxnSpPr/>
              <p:nvPr/>
            </p:nvCxnSpPr>
            <p:spPr>
              <a:xfrm flipV="1">
                <a:off x="5873448" y="4849026"/>
                <a:ext cx="1044272" cy="72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5" name="그룹 44"/>
          <p:cNvGrpSpPr/>
          <p:nvPr/>
        </p:nvGrpSpPr>
        <p:grpSpPr>
          <a:xfrm>
            <a:off x="266206" y="195036"/>
            <a:ext cx="4599428" cy="6605856"/>
            <a:chOff x="-564107" y="195036"/>
            <a:chExt cx="4599428" cy="6605856"/>
          </a:xfrm>
        </p:grpSpPr>
        <p:sp>
          <p:nvSpPr>
            <p:cNvPr id="46" name="TextBox 45"/>
            <p:cNvSpPr txBox="1"/>
            <p:nvPr/>
          </p:nvSpPr>
          <p:spPr>
            <a:xfrm>
              <a:off x="-2856" y="5046566"/>
              <a:ext cx="2260555" cy="1754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: marker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1 : 0% FBS antibody test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2 : 0% FBS antibody test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3 : 0% FBS antibody test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4 : 0% FBS antibody test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5 : 10% FBS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6 : 0% FBS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7 : Con (=pLKO.1)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8 : hST8Sia I </a:t>
              </a:r>
              <a:r>
                <a:rPr lang="en-US" altLang="ko-K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-2856" y="3687077"/>
              <a:ext cx="739305" cy="2159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-22860" y="2138717"/>
              <a:ext cx="20489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D3 synthase (hST8Sia I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 flipH="1">
              <a:off x="51334" y="2385782"/>
              <a:ext cx="2806701" cy="21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  1     2    3     4     5     6     7    8   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0" name="그림 4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565" y="195036"/>
              <a:ext cx="2929128" cy="1847088"/>
            </a:xfrm>
            <a:prstGeom prst="rect">
              <a:avLst/>
            </a:prstGeom>
          </p:spPr>
        </p:pic>
        <p:sp>
          <p:nvSpPr>
            <p:cNvPr id="51" name="TextBox 50"/>
            <p:cNvSpPr txBox="1"/>
            <p:nvPr/>
          </p:nvSpPr>
          <p:spPr>
            <a:xfrm>
              <a:off x="2995495" y="323919"/>
              <a:ext cx="314510" cy="17081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  <a:p>
              <a:endParaRPr lang="en-US" altLang="ko-KR" sz="2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endPara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pic>
          <p:nvPicPr>
            <p:cNvPr id="52" name="그림 5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4" t="8480" r="4123" b="2144"/>
            <a:stretch/>
          </p:blipFill>
          <p:spPr>
            <a:xfrm rot="-60000">
              <a:off x="51096" y="2626832"/>
              <a:ext cx="3168270" cy="1023340"/>
            </a:xfrm>
            <a:prstGeom prst="rect">
              <a:avLst/>
            </a:prstGeom>
          </p:spPr>
        </p:pic>
        <p:grpSp>
          <p:nvGrpSpPr>
            <p:cNvPr id="53" name="그룹 52"/>
            <p:cNvGrpSpPr/>
            <p:nvPr/>
          </p:nvGrpSpPr>
          <p:grpSpPr>
            <a:xfrm>
              <a:off x="2623002" y="3054829"/>
              <a:ext cx="1374005" cy="215909"/>
              <a:chOff x="2623002" y="3084461"/>
              <a:chExt cx="1374005" cy="215909"/>
            </a:xfrm>
          </p:grpSpPr>
          <p:sp>
            <p:nvSpPr>
              <p:cNvPr id="59" name="이등변 삼각형 58"/>
              <p:cNvSpPr/>
              <p:nvPr/>
            </p:nvSpPr>
            <p:spPr>
              <a:xfrm rot="16200000">
                <a:off x="3292966" y="3167499"/>
                <a:ext cx="85635" cy="107077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3344061" y="3084461"/>
                <a:ext cx="652946" cy="2159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kD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1" name="직선 연결선 60"/>
              <p:cNvCxnSpPr/>
              <p:nvPr/>
            </p:nvCxnSpPr>
            <p:spPr>
              <a:xfrm flipV="1">
                <a:off x="2623002" y="3225315"/>
                <a:ext cx="605052" cy="562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54" name="그림 53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33" t="7210" r="5902" b="13961"/>
            <a:stretch/>
          </p:blipFill>
          <p:spPr>
            <a:xfrm>
              <a:off x="-564107" y="3967678"/>
              <a:ext cx="3568700" cy="887959"/>
            </a:xfrm>
            <a:prstGeom prst="rect">
              <a:avLst/>
            </a:prstGeom>
          </p:spPr>
        </p:pic>
        <p:grpSp>
          <p:nvGrpSpPr>
            <p:cNvPr id="55" name="그룹 54"/>
            <p:cNvGrpSpPr/>
            <p:nvPr/>
          </p:nvGrpSpPr>
          <p:grpSpPr>
            <a:xfrm>
              <a:off x="2667128" y="4412644"/>
              <a:ext cx="1368193" cy="215909"/>
              <a:chOff x="2659964" y="4617309"/>
              <a:chExt cx="1368193" cy="215909"/>
            </a:xfrm>
          </p:grpSpPr>
          <p:sp>
            <p:nvSpPr>
              <p:cNvPr id="56" name="이등변 삼각형 55"/>
              <p:cNvSpPr/>
              <p:nvPr/>
            </p:nvSpPr>
            <p:spPr>
              <a:xfrm rot="16200000">
                <a:off x="3345574" y="4695732"/>
                <a:ext cx="85635" cy="103602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3396401" y="4617309"/>
                <a:ext cx="631756" cy="2159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7kD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8" name="직선 연결선 57"/>
              <p:cNvCxnSpPr/>
              <p:nvPr/>
            </p:nvCxnSpPr>
            <p:spPr>
              <a:xfrm>
                <a:off x="2659964" y="4751811"/>
                <a:ext cx="62553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0" name="그룹 79"/>
          <p:cNvGrpSpPr/>
          <p:nvPr/>
        </p:nvGrpSpPr>
        <p:grpSpPr>
          <a:xfrm>
            <a:off x="8917260" y="386659"/>
            <a:ext cx="2708542" cy="5846936"/>
            <a:chOff x="8086947" y="386659"/>
            <a:chExt cx="2708542" cy="5846936"/>
          </a:xfrm>
        </p:grpSpPr>
        <p:grpSp>
          <p:nvGrpSpPr>
            <p:cNvPr id="81" name="그룹 80"/>
            <p:cNvGrpSpPr/>
            <p:nvPr/>
          </p:nvGrpSpPr>
          <p:grpSpPr>
            <a:xfrm>
              <a:off x="8104981" y="2188343"/>
              <a:ext cx="2048959" cy="454547"/>
              <a:chOff x="4597994" y="2138717"/>
              <a:chExt cx="2048959" cy="454547"/>
            </a:xfrm>
          </p:grpSpPr>
          <p:sp>
            <p:nvSpPr>
              <p:cNvPr id="96" name="TextBox 95"/>
              <p:cNvSpPr txBox="1"/>
              <p:nvPr/>
            </p:nvSpPr>
            <p:spPr>
              <a:xfrm>
                <a:off x="4597994" y="2138717"/>
                <a:ext cx="20489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D3 synthase (hST8Sia I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flipH="1">
                <a:off x="4672188" y="2316265"/>
                <a:ext cx="14409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   2     3    4     m  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2" name="TextBox 81"/>
            <p:cNvSpPr txBox="1"/>
            <p:nvPr/>
          </p:nvSpPr>
          <p:spPr>
            <a:xfrm>
              <a:off x="8179175" y="3998509"/>
              <a:ext cx="739305" cy="177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8104981" y="5217932"/>
              <a:ext cx="202972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: 10% FBS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2 : 0% FBS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3 : Con (=pLKO.1)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 4 : hST8Sia I </a:t>
              </a:r>
              <a:r>
                <a:rPr lang="en-US" altLang="ko-K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</a:t>
              </a:r>
            </a:p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: marker</a:t>
              </a:r>
            </a:p>
          </p:txBody>
        </p:sp>
        <p:pic>
          <p:nvPicPr>
            <p:cNvPr id="84" name="그림 8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86947" y="386659"/>
              <a:ext cx="1533144" cy="1533144"/>
            </a:xfrm>
            <a:prstGeom prst="rect">
              <a:avLst/>
            </a:prstGeom>
          </p:spPr>
        </p:pic>
        <p:sp>
          <p:nvSpPr>
            <p:cNvPr id="85" name="TextBox 84"/>
            <p:cNvSpPr txBox="1"/>
            <p:nvPr/>
          </p:nvSpPr>
          <p:spPr>
            <a:xfrm>
              <a:off x="9467527" y="405295"/>
              <a:ext cx="314510" cy="1538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  <a:p>
              <a:endParaRPr lang="en-US" altLang="ko-KR" sz="2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endPara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3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endPara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endPara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pic>
          <p:nvPicPr>
            <p:cNvPr id="86" name="그림 85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12280" y="2618676"/>
              <a:ext cx="1853184" cy="1341120"/>
            </a:xfrm>
            <a:prstGeom prst="rect">
              <a:avLst/>
            </a:prstGeom>
          </p:spPr>
        </p:pic>
        <p:grpSp>
          <p:nvGrpSpPr>
            <p:cNvPr id="87" name="그룹 86"/>
            <p:cNvGrpSpPr/>
            <p:nvPr/>
          </p:nvGrpSpPr>
          <p:grpSpPr>
            <a:xfrm>
              <a:off x="9313966" y="3353117"/>
              <a:ext cx="1481523" cy="276999"/>
              <a:chOff x="6368881" y="3363516"/>
              <a:chExt cx="1374005" cy="276999"/>
            </a:xfrm>
          </p:grpSpPr>
          <p:sp>
            <p:nvSpPr>
              <p:cNvPr id="93" name="이등변 삼각형 92"/>
              <p:cNvSpPr/>
              <p:nvPr/>
            </p:nvSpPr>
            <p:spPr>
              <a:xfrm rot="16200000">
                <a:off x="7026730" y="3452609"/>
                <a:ext cx="109865" cy="107077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7089940" y="3363516"/>
                <a:ext cx="652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kD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5" name="직선 연결선 94"/>
              <p:cNvCxnSpPr/>
              <p:nvPr/>
            </p:nvCxnSpPr>
            <p:spPr>
              <a:xfrm flipV="1">
                <a:off x="6368881" y="3511636"/>
                <a:ext cx="605052" cy="72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88" name="그림 87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15903" y="4270360"/>
              <a:ext cx="1469136" cy="846082"/>
            </a:xfrm>
            <a:prstGeom prst="rect">
              <a:avLst/>
            </a:prstGeom>
          </p:spPr>
        </p:pic>
        <p:grpSp>
          <p:nvGrpSpPr>
            <p:cNvPr id="89" name="그룹 88"/>
            <p:cNvGrpSpPr/>
            <p:nvPr/>
          </p:nvGrpSpPr>
          <p:grpSpPr>
            <a:xfrm>
              <a:off x="9348454" y="4659863"/>
              <a:ext cx="1352682" cy="276999"/>
              <a:chOff x="6368881" y="3363516"/>
              <a:chExt cx="1374005" cy="276999"/>
            </a:xfrm>
          </p:grpSpPr>
          <p:sp>
            <p:nvSpPr>
              <p:cNvPr id="90" name="이등변 삼각형 89"/>
              <p:cNvSpPr/>
              <p:nvPr/>
            </p:nvSpPr>
            <p:spPr>
              <a:xfrm rot="16200000">
                <a:off x="7026730" y="3452609"/>
                <a:ext cx="109865" cy="107077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7089940" y="3363516"/>
                <a:ext cx="6529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7kD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2" name="직선 연결선 91"/>
              <p:cNvCxnSpPr/>
              <p:nvPr/>
            </p:nvCxnSpPr>
            <p:spPr>
              <a:xfrm flipV="1">
                <a:off x="6368881" y="3511636"/>
                <a:ext cx="605052" cy="72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TextBox 1"/>
          <p:cNvSpPr txBox="1"/>
          <p:nvPr/>
        </p:nvSpPr>
        <p:spPr>
          <a:xfrm>
            <a:off x="0" y="744967"/>
            <a:ext cx="10058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irst data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221130" y="732167"/>
            <a:ext cx="11815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econd data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658103" y="744967"/>
            <a:ext cx="11815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Third data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118778" y="6317913"/>
            <a:ext cx="3130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econd data are shown in Fig. 2 and Fig 6.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93519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</TotalTime>
  <Words>218</Words>
  <Application>Microsoft Office PowerPoint</Application>
  <PresentationFormat>와이드스크린</PresentationFormat>
  <Paragraphs>9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계정</dc:creator>
  <cp:lastModifiedBy>김철호</cp:lastModifiedBy>
  <cp:revision>28</cp:revision>
  <dcterms:created xsi:type="dcterms:W3CDTF">2022-10-27T07:31:13Z</dcterms:created>
  <dcterms:modified xsi:type="dcterms:W3CDTF">2023-03-07T08:12:24Z</dcterms:modified>
</cp:coreProperties>
</file>